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368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3920" bIns="439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368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3920" bIns="439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8400"/>
            <a:ext cx="4648320" cy="348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140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3920" bIns="439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31160"/>
            <a:ext cx="3038400" cy="46368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3920" bIns="439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31160"/>
            <a:ext cx="3038400" cy="46368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3920" bIns="43920" anchor="b">
            <a:noAutofit/>
          </a:bodyPr>
          <a:lstStyle>
            <a:lvl1pPr indent="0" algn="r">
              <a:buNone/>
              <a:tabLst>
                <a:tab algn="l" pos="0"/>
                <a:tab algn="l" pos="880920"/>
                <a:tab algn="l" pos="1762200"/>
                <a:tab algn="l" pos="2643120"/>
                <a:tab algn="l" pos="3524400"/>
                <a:tab algn="l" pos="4405320"/>
                <a:tab algn="l" pos="5286240"/>
                <a:tab algn="l" pos="6167520"/>
                <a:tab algn="l" pos="7048440"/>
                <a:tab algn="l" pos="7929720"/>
                <a:tab algn="l" pos="8810640"/>
                <a:tab algn="l" pos="9691560"/>
                <a:tab algn="l" pos="105728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80920"/>
                <a:tab algn="l" pos="1762200"/>
                <a:tab algn="l" pos="2643120"/>
                <a:tab algn="l" pos="3524400"/>
                <a:tab algn="l" pos="4405320"/>
                <a:tab algn="l" pos="5286240"/>
                <a:tab algn="l" pos="6167520"/>
                <a:tab algn="l" pos="7048440"/>
                <a:tab algn="l" pos="7929720"/>
                <a:tab algn="l" pos="8810640"/>
                <a:tab algn="l" pos="9691560"/>
                <a:tab algn="l" pos="10572840"/>
              </a:tabLst>
            </a:pPr>
            <a:fld id="{A8040027-9096-4380-80FB-D8F0673BDE7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Rectangle 7"/>
          <p:cNvSpPr/>
          <p:nvPr/>
        </p:nvSpPr>
        <p:spPr>
          <a:xfrm>
            <a:off x="3970440" y="8831160"/>
            <a:ext cx="303840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8200" rIns="88200" tIns="43920" bIns="43920" anchor="b">
            <a:noAutofit/>
          </a:bodyPr>
          <a:p>
            <a:pPr algn="r">
              <a:tabLst>
                <a:tab algn="l" pos="0"/>
                <a:tab algn="l" pos="880920"/>
                <a:tab algn="l" pos="1762200"/>
                <a:tab algn="l" pos="2643120"/>
                <a:tab algn="l" pos="3524400"/>
                <a:tab algn="l" pos="4405320"/>
                <a:tab algn="l" pos="5286240"/>
                <a:tab algn="l" pos="6167520"/>
                <a:tab algn="l" pos="7048440"/>
                <a:tab algn="l" pos="7929720"/>
                <a:tab algn="l" pos="8810640"/>
                <a:tab algn="l" pos="9691560"/>
                <a:tab algn="l" pos="10572840"/>
              </a:tabLst>
            </a:pPr>
            <a:fld id="{B6AE9549-797B-49BF-970F-EF5CF279C51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54" name="PlaceHolder 1"/>
          <p:cNvSpPr>
            <a:spLocks noGrp="1"/>
          </p:cNvSpPr>
          <p:nvPr>
            <p:ph type="sldImg"/>
          </p:nvPr>
        </p:nvSpPr>
        <p:spPr>
          <a:xfrm>
            <a:off x="1181160" y="69840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5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Rectangle 7"/>
          <p:cNvSpPr/>
          <p:nvPr/>
        </p:nvSpPr>
        <p:spPr>
          <a:xfrm>
            <a:off x="3970440" y="8831160"/>
            <a:ext cx="303840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8200" rIns="88200" tIns="43920" bIns="43920" anchor="b">
            <a:noAutofit/>
          </a:bodyPr>
          <a:p>
            <a:pPr algn="r">
              <a:tabLst>
                <a:tab algn="l" pos="0"/>
                <a:tab algn="l" pos="880920"/>
                <a:tab algn="l" pos="1762200"/>
                <a:tab algn="l" pos="2643120"/>
                <a:tab algn="l" pos="3524400"/>
                <a:tab algn="l" pos="4405320"/>
                <a:tab algn="l" pos="5286240"/>
                <a:tab algn="l" pos="6167520"/>
                <a:tab algn="l" pos="7048440"/>
                <a:tab algn="l" pos="7929720"/>
                <a:tab algn="l" pos="8810640"/>
                <a:tab algn="l" pos="9691560"/>
                <a:tab algn="l" pos="10572840"/>
              </a:tabLst>
            </a:pPr>
            <a:fld id="{63467101-FDDA-47BE-890C-DDBFBE925C6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57" name="PlaceHolder 1"/>
          <p:cNvSpPr>
            <a:spLocks noGrp="1"/>
          </p:cNvSpPr>
          <p:nvPr>
            <p:ph type="sldImg"/>
          </p:nvPr>
        </p:nvSpPr>
        <p:spPr>
          <a:xfrm>
            <a:off x="1181160" y="69840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5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Rectangle 7"/>
          <p:cNvSpPr/>
          <p:nvPr/>
        </p:nvSpPr>
        <p:spPr>
          <a:xfrm>
            <a:off x="3970440" y="8831160"/>
            <a:ext cx="303840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8200" rIns="88200" tIns="43920" bIns="43920" anchor="b">
            <a:noAutofit/>
          </a:bodyPr>
          <a:p>
            <a:pPr algn="r">
              <a:tabLst>
                <a:tab algn="l" pos="0"/>
                <a:tab algn="l" pos="880920"/>
                <a:tab algn="l" pos="1762200"/>
                <a:tab algn="l" pos="2643120"/>
                <a:tab algn="l" pos="3524400"/>
                <a:tab algn="l" pos="4405320"/>
                <a:tab algn="l" pos="5286240"/>
                <a:tab algn="l" pos="6167520"/>
                <a:tab algn="l" pos="7048440"/>
                <a:tab algn="l" pos="7929720"/>
                <a:tab algn="l" pos="8810640"/>
                <a:tab algn="l" pos="9691560"/>
                <a:tab algn="l" pos="10572840"/>
              </a:tabLst>
            </a:pPr>
            <a:fld id="{76CAE273-48AC-4F8C-9332-66B2128A122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60" name="PlaceHolder 1"/>
          <p:cNvSpPr>
            <a:spLocks noGrp="1"/>
          </p:cNvSpPr>
          <p:nvPr>
            <p:ph type="sldImg"/>
          </p:nvPr>
        </p:nvSpPr>
        <p:spPr>
          <a:xfrm>
            <a:off x="1181160" y="69840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6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42686-2D39-4A17-8355-0AA0968A9D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A2610-D05C-4449-AE0A-A5D6F55411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7CA33-F188-4490-BAD5-8099139D44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6C3ED-3642-409A-B6D2-1830A8BBF9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8A921-F23C-4EBD-89FE-E33DEB08B9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1C950-889F-426B-A957-F68A4D4E3B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0F499-5733-4A3A-9AE7-06B88C1FF7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9FCC2-4183-4D90-90C7-DAF788FB15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C04F0-BA8D-44E1-A1E0-81FB868F6D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FA850-9652-4B32-BA61-E79C7BD841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09383-61CE-45FA-AE07-F9EFAFA925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FC9E0-7051-4B38-A210-D5B1EC052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042793-7344-4219-86FD-85DB56FDB61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pn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4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5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6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7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8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9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0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21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3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oleObject" Target="../embeddings/oleObject4.bin"/><Relationship Id="rId11" Type="http://schemas.openxmlformats.org/officeDocument/2006/relationships/image" Target="../media/image28.png"/><Relationship Id="rId12" Type="http://schemas.openxmlformats.org/officeDocument/2006/relationships/image" Target="../media/image29.png"/><Relationship Id="rId13" Type="http://schemas.openxmlformats.org/officeDocument/2006/relationships/oleObject" Target="../embeddings/oleObject5.bin"/><Relationship Id="rId14" Type="http://schemas.openxmlformats.org/officeDocument/2006/relationships/image" Target="../media/image30.png"/><Relationship Id="rId15" Type="http://schemas.openxmlformats.org/officeDocument/2006/relationships/slideLayout" Target="../slideLayouts/slideLayout1.xml"/><Relationship Id="rId16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67"/>
          <p:cNvGrpSpPr/>
          <p:nvPr/>
        </p:nvGrpSpPr>
        <p:grpSpPr>
          <a:xfrm>
            <a:off x="3205440" y="149400"/>
            <a:ext cx="5024160" cy="5717880"/>
            <a:chOff x="3205440" y="149400"/>
            <a:chExt cx="5024160" cy="5717880"/>
          </a:xfrm>
        </p:grpSpPr>
        <p:sp>
          <p:nvSpPr>
            <p:cNvPr id="49" name="Text Box 41"/>
            <p:cNvSpPr/>
            <p:nvPr/>
          </p:nvSpPr>
          <p:spPr>
            <a:xfrm>
              <a:off x="3205440" y="861840"/>
              <a:ext cx="1721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efore Infection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0" name="Text Box 43"/>
            <p:cNvSpPr/>
            <p:nvPr/>
          </p:nvSpPr>
          <p:spPr>
            <a:xfrm>
              <a:off x="5149440" y="838080"/>
              <a:ext cx="117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4 days PI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1" name="Text Box 44"/>
            <p:cNvSpPr/>
            <p:nvPr/>
          </p:nvSpPr>
          <p:spPr>
            <a:xfrm>
              <a:off x="6825600" y="838080"/>
              <a:ext cx="117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8 days PI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2" name="Line 45"/>
            <p:cNvSpPr/>
            <p:nvPr/>
          </p:nvSpPr>
          <p:spPr>
            <a:xfrm>
              <a:off x="3276720" y="838080"/>
              <a:ext cx="4952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3" name="Text Box 46"/>
            <p:cNvSpPr/>
            <p:nvPr/>
          </p:nvSpPr>
          <p:spPr>
            <a:xfrm>
              <a:off x="4508640" y="457200"/>
              <a:ext cx="2341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8-GFP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-transfer (IP)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4" name="Line 47"/>
            <p:cNvSpPr/>
            <p:nvPr/>
          </p:nvSpPr>
          <p:spPr>
            <a:xfrm>
              <a:off x="3276720" y="457200"/>
              <a:ext cx="4952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5" name="Text Box 48"/>
            <p:cNvSpPr/>
            <p:nvPr/>
          </p:nvSpPr>
          <p:spPr>
            <a:xfrm>
              <a:off x="3976920" y="149400"/>
              <a:ext cx="243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8</a:t>
              </a:r>
              <a:r>
                <a:rPr b="1" lang="en-US" sz="1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 recipient mouse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graphicFrame>
          <p:nvGraphicFramePr>
            <p:cNvPr id="56" name="Object 55"/>
            <p:cNvGraphicFramePr/>
            <p:nvPr/>
          </p:nvGraphicFramePr>
          <p:xfrm>
            <a:off x="3276720" y="1219320"/>
            <a:ext cx="1600200" cy="14475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7" name="Object 55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276720" y="12193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8" name="Object 56"/>
            <p:cNvGraphicFramePr/>
            <p:nvPr/>
          </p:nvGraphicFramePr>
          <p:xfrm>
            <a:off x="4953240" y="1219320"/>
            <a:ext cx="1600200" cy="14475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9" name="Object 5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953240" y="12193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0" name="Object 57"/>
            <p:cNvGraphicFramePr/>
            <p:nvPr/>
          </p:nvGraphicFramePr>
          <p:xfrm>
            <a:off x="6629400" y="1219320"/>
            <a:ext cx="1600200" cy="144756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61" name="Object 5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6629400" y="12193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2" name="Object 58"/>
            <p:cNvGraphicFramePr/>
            <p:nvPr/>
          </p:nvGraphicFramePr>
          <p:xfrm>
            <a:off x="3276720" y="2819520"/>
            <a:ext cx="1600200" cy="14475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63" name="Object 58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27672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4" name="Object 59"/>
            <p:cNvGraphicFramePr/>
            <p:nvPr/>
          </p:nvGraphicFramePr>
          <p:xfrm>
            <a:off x="4953240" y="2819520"/>
            <a:ext cx="1600200" cy="144756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65" name="Object 59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95324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6" name="Object 60"/>
            <p:cNvGraphicFramePr/>
            <p:nvPr/>
          </p:nvGraphicFramePr>
          <p:xfrm>
            <a:off x="6629400" y="2819520"/>
            <a:ext cx="1600200" cy="144756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67" name="Object 60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662940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8" name="Object 61"/>
            <p:cNvGraphicFramePr/>
            <p:nvPr/>
          </p:nvGraphicFramePr>
          <p:xfrm>
            <a:off x="3276720" y="4419720"/>
            <a:ext cx="1600200" cy="143028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69" name="Object 61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276720" y="4419720"/>
                      <a:ext cx="1600200" cy="1430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0" name="Object 62"/>
            <p:cNvGraphicFramePr/>
            <p:nvPr/>
          </p:nvGraphicFramePr>
          <p:xfrm>
            <a:off x="4953240" y="4419720"/>
            <a:ext cx="1600200" cy="144756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71" name="Object 62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4953240" y="44197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2" name="Object 63"/>
            <p:cNvGraphicFramePr/>
            <p:nvPr/>
          </p:nvGraphicFramePr>
          <p:xfrm>
            <a:off x="6629400" y="4419720"/>
            <a:ext cx="1600200" cy="144756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73" name="Object 63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6629400" y="44197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74" name="Text Box 2"/>
          <p:cNvSpPr/>
          <p:nvPr/>
        </p:nvSpPr>
        <p:spPr>
          <a:xfrm rot="16200000">
            <a:off x="836640" y="327996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M</a:t>
            </a: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75" name="Text Box 38"/>
          <p:cNvSpPr/>
          <p:nvPr/>
        </p:nvSpPr>
        <p:spPr>
          <a:xfrm rot="16200000">
            <a:off x="848880" y="1742760"/>
            <a:ext cx="49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76" name="Text Box 39"/>
          <p:cNvSpPr/>
          <p:nvPr/>
        </p:nvSpPr>
        <p:spPr>
          <a:xfrm rot="16200000">
            <a:off x="653760" y="4911480"/>
            <a:ext cx="88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77" name="Text Box 40"/>
          <p:cNvSpPr/>
          <p:nvPr/>
        </p:nvSpPr>
        <p:spPr>
          <a:xfrm>
            <a:off x="1451160" y="861840"/>
            <a:ext cx="97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T-GFP</a:t>
            </a:r>
            <a:endParaRPr b="0" lang="en-US" sz="16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graphicFrame>
        <p:nvGraphicFramePr>
          <p:cNvPr id="78" name="Object 64"/>
          <p:cNvGraphicFramePr/>
          <p:nvPr/>
        </p:nvGraphicFramePr>
        <p:xfrm>
          <a:off x="1295280" y="4419720"/>
          <a:ext cx="1600200" cy="144756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79" name="Object 64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1295280" y="4419720"/>
                    <a:ext cx="1600200" cy="144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0" name="Object 65"/>
          <p:cNvGraphicFramePr/>
          <p:nvPr/>
        </p:nvGraphicFramePr>
        <p:xfrm>
          <a:off x="1295280" y="1219320"/>
          <a:ext cx="1600200" cy="144756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81" name="Object 65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1295280" y="1219320"/>
                    <a:ext cx="1600200" cy="144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Object 66"/>
          <p:cNvGraphicFramePr/>
          <p:nvPr/>
        </p:nvGraphicFramePr>
        <p:xfrm>
          <a:off x="1295280" y="2819520"/>
          <a:ext cx="1600200" cy="143640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83" name="Object 66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295280" y="2819520"/>
                    <a:ext cx="1600200" cy="143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" name="Text Box 69"/>
          <p:cNvSpPr/>
          <p:nvPr/>
        </p:nvSpPr>
        <p:spPr>
          <a:xfrm>
            <a:off x="361800" y="15228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85" name="Line 70"/>
          <p:cNvSpPr/>
          <p:nvPr/>
        </p:nvSpPr>
        <p:spPr>
          <a:xfrm>
            <a:off x="380880" y="609480"/>
            <a:ext cx="381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43"/>
          <p:cNvGrpSpPr/>
          <p:nvPr/>
        </p:nvGrpSpPr>
        <p:grpSpPr>
          <a:xfrm>
            <a:off x="1752480" y="149400"/>
            <a:ext cx="5410440" cy="5717880"/>
            <a:chOff x="1752480" y="149400"/>
            <a:chExt cx="5410440" cy="5717880"/>
          </a:xfrm>
        </p:grpSpPr>
        <p:sp>
          <p:nvSpPr>
            <p:cNvPr id="87" name="Text Box 2"/>
            <p:cNvSpPr/>
            <p:nvPr/>
          </p:nvSpPr>
          <p:spPr>
            <a:xfrm rot="16200000">
              <a:off x="1674720" y="3279960"/>
              <a:ext cx="52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M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grpSp>
          <p:nvGrpSpPr>
            <p:cNvPr id="88" name="Group 32"/>
            <p:cNvGrpSpPr/>
            <p:nvPr/>
          </p:nvGrpSpPr>
          <p:grpSpPr>
            <a:xfrm>
              <a:off x="2209680" y="1219320"/>
              <a:ext cx="4952880" cy="4647960"/>
              <a:chOff x="2209680" y="1219320"/>
              <a:chExt cx="4952880" cy="4647960"/>
            </a:xfrm>
          </p:grpSpPr>
          <p:sp>
            <p:nvSpPr>
              <p:cNvPr id="89" name="Rectangle 7"/>
              <p:cNvSpPr/>
              <p:nvPr/>
            </p:nvSpPr>
            <p:spPr>
              <a:xfrm>
                <a:off x="2209680" y="12193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0" name="Rectangle 8"/>
              <p:cNvSpPr/>
              <p:nvPr/>
            </p:nvSpPr>
            <p:spPr>
              <a:xfrm>
                <a:off x="3886200" y="12193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1" name="Rectangle 9"/>
              <p:cNvSpPr/>
              <p:nvPr/>
            </p:nvSpPr>
            <p:spPr>
              <a:xfrm>
                <a:off x="5562360" y="12193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2" name="Rectangle 13"/>
              <p:cNvSpPr/>
              <p:nvPr/>
            </p:nvSpPr>
            <p:spPr>
              <a:xfrm>
                <a:off x="2209680" y="28195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3" name="Rectangle 14"/>
              <p:cNvSpPr/>
              <p:nvPr/>
            </p:nvSpPr>
            <p:spPr>
              <a:xfrm>
                <a:off x="3886200" y="28195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4" name="Rectangle 15"/>
              <p:cNvSpPr/>
              <p:nvPr/>
            </p:nvSpPr>
            <p:spPr>
              <a:xfrm>
                <a:off x="5562360" y="28195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5" name="Rectangle 19"/>
              <p:cNvSpPr/>
              <p:nvPr/>
            </p:nvSpPr>
            <p:spPr>
              <a:xfrm>
                <a:off x="2209680" y="44197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6" name="Rectangle 20"/>
              <p:cNvSpPr/>
              <p:nvPr/>
            </p:nvSpPr>
            <p:spPr>
              <a:xfrm>
                <a:off x="3886200" y="44197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97" name="Rectangle 21"/>
              <p:cNvSpPr/>
              <p:nvPr/>
            </p:nvSpPr>
            <p:spPr>
              <a:xfrm>
                <a:off x="5562360" y="4419720"/>
                <a:ext cx="1600200" cy="144756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</p:grpSp>
        <p:sp>
          <p:nvSpPr>
            <p:cNvPr id="98" name="Text Box 22"/>
            <p:cNvSpPr/>
            <p:nvPr/>
          </p:nvSpPr>
          <p:spPr>
            <a:xfrm rot="16200000">
              <a:off x="1686960" y="1742760"/>
              <a:ext cx="49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G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9" name="Text Box 23"/>
            <p:cNvSpPr/>
            <p:nvPr/>
          </p:nvSpPr>
          <p:spPr>
            <a:xfrm rot="16200000">
              <a:off x="1491840" y="4911480"/>
              <a:ext cx="889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pleen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0" name="Text Box 25"/>
            <p:cNvSpPr/>
            <p:nvPr/>
          </p:nvSpPr>
          <p:spPr>
            <a:xfrm>
              <a:off x="2138760" y="861840"/>
              <a:ext cx="1721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efore Infection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1" name="Text Box 26"/>
            <p:cNvSpPr/>
            <p:nvPr/>
          </p:nvSpPr>
          <p:spPr>
            <a:xfrm>
              <a:off x="4082400" y="838080"/>
              <a:ext cx="117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4 days PI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2" name="Text Box 27"/>
            <p:cNvSpPr/>
            <p:nvPr/>
          </p:nvSpPr>
          <p:spPr>
            <a:xfrm>
              <a:off x="5758920" y="838080"/>
              <a:ext cx="117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8 days PI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3" name="Line 28"/>
            <p:cNvSpPr/>
            <p:nvPr/>
          </p:nvSpPr>
          <p:spPr>
            <a:xfrm>
              <a:off x="2209680" y="838080"/>
              <a:ext cx="4953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4" name="Text Box 29"/>
            <p:cNvSpPr/>
            <p:nvPr/>
          </p:nvSpPr>
          <p:spPr>
            <a:xfrm>
              <a:off x="3518280" y="457200"/>
              <a:ext cx="2251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M-GFP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-transfer (IV)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5" name="Line 30"/>
            <p:cNvSpPr/>
            <p:nvPr/>
          </p:nvSpPr>
          <p:spPr>
            <a:xfrm>
              <a:off x="2209680" y="457200"/>
              <a:ext cx="4953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6" name="Text Box 31"/>
            <p:cNvSpPr/>
            <p:nvPr/>
          </p:nvSpPr>
          <p:spPr>
            <a:xfrm>
              <a:off x="3976920" y="149400"/>
              <a:ext cx="243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8</a:t>
              </a:r>
              <a:r>
                <a:rPr b="1" lang="en-US" sz="1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 recipient mouse</a:t>
              </a:r>
              <a:endParaRPr b="0" lang="en-US" sz="16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graphicFrame>
          <p:nvGraphicFramePr>
            <p:cNvPr id="107" name="Object 33"/>
            <p:cNvGraphicFramePr/>
            <p:nvPr/>
          </p:nvGraphicFramePr>
          <p:xfrm>
            <a:off x="2209680" y="1219320"/>
            <a:ext cx="1600200" cy="14284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08" name="Object 3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209680" y="1219320"/>
                      <a:ext cx="1600200" cy="1428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9" name="Object 34"/>
            <p:cNvGraphicFramePr/>
            <p:nvPr/>
          </p:nvGraphicFramePr>
          <p:xfrm>
            <a:off x="3886200" y="1219320"/>
            <a:ext cx="1600200" cy="14475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10" name="Object 34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886200" y="12193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11" name="Object 35"/>
            <p:cNvGraphicFramePr/>
            <p:nvPr/>
          </p:nvGraphicFramePr>
          <p:xfrm>
            <a:off x="5562720" y="1219320"/>
            <a:ext cx="1600200" cy="142848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12" name="Object 35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562720" y="1219320"/>
                      <a:ext cx="1600200" cy="1428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13" name="Object 36"/>
            <p:cNvGraphicFramePr/>
            <p:nvPr/>
          </p:nvGraphicFramePr>
          <p:xfrm>
            <a:off x="2209680" y="2819520"/>
            <a:ext cx="1600200" cy="14475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14" name="Object 36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20968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15" name="Object 37"/>
            <p:cNvGraphicFramePr/>
            <p:nvPr/>
          </p:nvGraphicFramePr>
          <p:xfrm>
            <a:off x="3886200" y="2819520"/>
            <a:ext cx="1600200" cy="144756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16" name="Object 37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88620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17" name="Object 38"/>
            <p:cNvGraphicFramePr/>
            <p:nvPr/>
          </p:nvGraphicFramePr>
          <p:xfrm>
            <a:off x="5562720" y="2819520"/>
            <a:ext cx="1600200" cy="144756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18" name="Object 38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5562720" y="28195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19" name="Object 39"/>
            <p:cNvGraphicFramePr/>
            <p:nvPr/>
          </p:nvGraphicFramePr>
          <p:xfrm>
            <a:off x="2209680" y="4419720"/>
            <a:ext cx="1600200" cy="144756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20" name="Object 39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2209680" y="44197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21" name="Object 40"/>
            <p:cNvGraphicFramePr/>
            <p:nvPr/>
          </p:nvGraphicFramePr>
          <p:xfrm>
            <a:off x="3886200" y="4419720"/>
            <a:ext cx="1600200" cy="144756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122" name="Object 40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886200" y="44197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23" name="Object 41"/>
            <p:cNvGraphicFramePr/>
            <p:nvPr/>
          </p:nvGraphicFramePr>
          <p:xfrm>
            <a:off x="5562720" y="4419720"/>
            <a:ext cx="1600200" cy="144756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124" name="Object 41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5562720" y="4419720"/>
                      <a:ext cx="1600200" cy="1447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125" name="Text Box 44"/>
          <p:cNvSpPr/>
          <p:nvPr/>
        </p:nvSpPr>
        <p:spPr>
          <a:xfrm>
            <a:off x="361800" y="15228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26" name="Line 45"/>
          <p:cNvSpPr/>
          <p:nvPr/>
        </p:nvSpPr>
        <p:spPr>
          <a:xfrm>
            <a:off x="380880" y="609480"/>
            <a:ext cx="381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4"/>
          <p:cNvGrpSpPr/>
          <p:nvPr/>
        </p:nvGrpSpPr>
        <p:grpSpPr>
          <a:xfrm>
            <a:off x="1066680" y="609480"/>
            <a:ext cx="5943600" cy="4648320"/>
            <a:chOff x="1066680" y="609480"/>
            <a:chExt cx="5943600" cy="4648320"/>
          </a:xfrm>
        </p:grpSpPr>
        <p:sp>
          <p:nvSpPr>
            <p:cNvPr id="128" name="Rectangle 9"/>
            <p:cNvSpPr/>
            <p:nvPr/>
          </p:nvSpPr>
          <p:spPr>
            <a:xfrm rot="16200000">
              <a:off x="721080" y="1429920"/>
              <a:ext cx="1081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PLEEN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grpSp>
          <p:nvGrpSpPr>
            <p:cNvPr id="129" name="Group 10"/>
            <p:cNvGrpSpPr/>
            <p:nvPr/>
          </p:nvGrpSpPr>
          <p:grpSpPr>
            <a:xfrm>
              <a:off x="1947960" y="609480"/>
              <a:ext cx="4639320" cy="368280"/>
              <a:chOff x="1947960" y="609480"/>
              <a:chExt cx="4639320" cy="368280"/>
            </a:xfrm>
          </p:grpSpPr>
          <p:sp>
            <p:nvSpPr>
              <p:cNvPr id="130" name="Rectangle 11"/>
              <p:cNvSpPr/>
              <p:nvPr/>
            </p:nvSpPr>
            <p:spPr>
              <a:xfrm>
                <a:off x="3475080" y="609480"/>
                <a:ext cx="1550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anti-GFP-488</a:t>
                </a: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131" name="Rectangle 12"/>
              <p:cNvSpPr/>
              <p:nvPr/>
            </p:nvSpPr>
            <p:spPr>
              <a:xfrm>
                <a:off x="1947960" y="609480"/>
                <a:ext cx="71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DAPI</a:t>
                </a: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  <p:sp>
            <p:nvSpPr>
              <p:cNvPr id="132" name="Rectangle 13"/>
              <p:cNvSpPr/>
              <p:nvPr/>
            </p:nvSpPr>
            <p:spPr>
              <a:xfrm>
                <a:off x="5568480" y="609480"/>
                <a:ext cx="1018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MERGE</a:t>
                </a:r>
                <a:endParaRPr b="0" lang="en-US" sz="1800" spc="-1" strike="noStrike" u="sng">
                  <a:solidFill>
                    <a:srgbClr val="000000"/>
                  </a:solidFill>
                  <a:uFillTx/>
                  <a:latin typeface="Arial"/>
                </a:endParaRPr>
              </a:p>
            </p:txBody>
          </p:sp>
        </p:grpSp>
        <p:sp>
          <p:nvSpPr>
            <p:cNvPr id="133" name="Rectangle 17"/>
            <p:cNvSpPr/>
            <p:nvPr/>
          </p:nvSpPr>
          <p:spPr>
            <a:xfrm rot="16200000">
              <a:off x="689040" y="2833200"/>
              <a:ext cx="1145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HYMUS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grpSp>
          <p:nvGrpSpPr>
            <p:cNvPr id="134" name="Group 11"/>
            <p:cNvGrpSpPr/>
            <p:nvPr/>
          </p:nvGrpSpPr>
          <p:grpSpPr>
            <a:xfrm>
              <a:off x="1447920" y="914400"/>
              <a:ext cx="5562360" cy="4343400"/>
              <a:chOff x="1447920" y="914400"/>
              <a:chExt cx="5562360" cy="4343400"/>
            </a:xfrm>
          </p:grpSpPr>
          <p:graphicFrame>
            <p:nvGraphicFramePr>
              <p:cNvPr id="135" name="Object 13"/>
              <p:cNvGraphicFramePr/>
              <p:nvPr/>
            </p:nvGraphicFramePr>
            <p:xfrm>
              <a:off x="5257800" y="914400"/>
              <a:ext cx="1727280" cy="129528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136" name="Object 13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5257800" y="914400"/>
                        <a:ext cx="1727280" cy="1295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7" name="Object 14"/>
              <p:cNvGraphicFramePr/>
              <p:nvPr/>
            </p:nvGraphicFramePr>
            <p:xfrm>
              <a:off x="3352680" y="914400"/>
              <a:ext cx="1752840" cy="131436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138" name="Object 14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3352680" y="914400"/>
                        <a:ext cx="1752840" cy="1314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9" name="Object 19"/>
              <p:cNvGraphicFramePr/>
              <p:nvPr/>
            </p:nvGraphicFramePr>
            <p:xfrm>
              <a:off x="1474920" y="914400"/>
              <a:ext cx="1725480" cy="131436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140" name="Object 19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1474920" y="914400"/>
                        <a:ext cx="1725480" cy="1314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pic>
            <p:nvPicPr>
              <p:cNvPr id="141" name="Picture 12" descr=""/>
              <p:cNvPicPr/>
              <p:nvPr/>
            </p:nvPicPr>
            <p:blipFill>
              <a:blip r:embed="rId7"/>
              <a:stretch/>
            </p:blipFill>
            <p:spPr>
              <a:xfrm>
                <a:off x="3352680" y="2438280"/>
                <a:ext cx="1752840" cy="1314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2" name="Picture 13" descr=""/>
              <p:cNvPicPr/>
              <p:nvPr/>
            </p:nvPicPr>
            <p:blipFill>
              <a:blip r:embed="rId8"/>
              <a:stretch/>
            </p:blipFill>
            <p:spPr>
              <a:xfrm>
                <a:off x="1447920" y="2438280"/>
                <a:ext cx="1752480" cy="1314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3" name="Picture 14" descr=""/>
              <p:cNvPicPr/>
              <p:nvPr/>
            </p:nvPicPr>
            <p:blipFill>
              <a:blip r:embed="rId9"/>
              <a:stretch/>
            </p:blipFill>
            <p:spPr>
              <a:xfrm>
                <a:off x="5257800" y="2438280"/>
                <a:ext cx="1752480" cy="1314720"/>
              </a:xfrm>
              <a:prstGeom prst="rect">
                <a:avLst/>
              </a:prstGeom>
              <a:ln w="0">
                <a:noFill/>
              </a:ln>
            </p:spPr>
          </p:pic>
          <p:graphicFrame>
            <p:nvGraphicFramePr>
              <p:cNvPr id="144" name="Object 7"/>
              <p:cNvGraphicFramePr/>
              <p:nvPr/>
            </p:nvGraphicFramePr>
            <p:xfrm>
              <a:off x="1447920" y="3962520"/>
              <a:ext cx="1752480" cy="1295280"/>
            </p:xfrm>
            <a:graphic>
              <a:graphicData uri="http://schemas.openxmlformats.org/presentationml/2006/ole">
                <p:oleObj r:id="rId10" spid="">
                  <p:embed/>
                  <p:pic>
                    <p:nvPicPr>
                      <p:cNvPr id="145" name="Object 7" descr=""/>
                      <p:cNvPicPr/>
                      <p:nvPr/>
                    </p:nvPicPr>
                    <p:blipFill>
                      <a:blip r:embed="rId11"/>
                      <a:stretch/>
                    </p:blipFill>
                    <p:spPr>
                      <a:xfrm>
                        <a:off x="1447920" y="3962520"/>
                        <a:ext cx="1752480" cy="1295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pic>
            <p:nvPicPr>
              <p:cNvPr id="146" name="Picture 18" descr=""/>
              <p:cNvPicPr/>
              <p:nvPr/>
            </p:nvPicPr>
            <p:blipFill>
              <a:blip r:embed="rId12"/>
              <a:stretch/>
            </p:blipFill>
            <p:spPr>
              <a:xfrm>
                <a:off x="3352680" y="3962520"/>
                <a:ext cx="1752840" cy="1295280"/>
              </a:xfrm>
              <a:prstGeom prst="rect">
                <a:avLst/>
              </a:prstGeom>
              <a:ln w="0">
                <a:noFill/>
              </a:ln>
            </p:spPr>
          </p:pic>
          <p:graphicFrame>
            <p:nvGraphicFramePr>
              <p:cNvPr id="147" name="Object 5"/>
              <p:cNvGraphicFramePr/>
              <p:nvPr/>
            </p:nvGraphicFramePr>
            <p:xfrm>
              <a:off x="5257800" y="3962520"/>
              <a:ext cx="1752480" cy="129528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148" name="Object 5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5257800" y="3962520"/>
                        <a:ext cx="1752480" cy="1295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149" name="Rectangle 21"/>
            <p:cNvSpPr/>
            <p:nvPr/>
          </p:nvSpPr>
          <p:spPr>
            <a:xfrm rot="16200000">
              <a:off x="1001160" y="4335120"/>
              <a:ext cx="49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G</a:t>
              </a: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</p:grpSp>
      <p:sp>
        <p:nvSpPr>
          <p:cNvPr id="150" name="Text Box 22"/>
          <p:cNvSpPr/>
          <p:nvPr/>
        </p:nvSpPr>
        <p:spPr>
          <a:xfrm>
            <a:off x="361800" y="15228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32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51" name="Line 23"/>
          <p:cNvSpPr/>
          <p:nvPr/>
        </p:nvSpPr>
        <p:spPr>
          <a:xfrm>
            <a:off x="380880" y="609480"/>
            <a:ext cx="381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52" name="Rectangle 12"/>
          <p:cNvSpPr/>
          <p:nvPr/>
        </p:nvSpPr>
        <p:spPr>
          <a:xfrm>
            <a:off x="8006400" y="594360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4T21:33:02Z</dcterms:created>
  <dc:creator>allensx</dc:creator>
  <dc:description/>
  <dc:language>en-US</dc:language>
  <cp:lastModifiedBy>Ghiasi, Homayon. Ph.D.</cp:lastModifiedBy>
  <dcterms:modified xsi:type="dcterms:W3CDTF">2013-10-21T23:26:04Z</dcterms:modified>
  <cp:revision>23</cp:revision>
  <dc:subject/>
  <dc:title>Slide 1</dc:title>
</cp:coreProperties>
</file>